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5AA00"/>
    <a:srgbClr val="AA0065"/>
    <a:srgbClr val="004277"/>
    <a:srgbClr val="296DC0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10" autoAdjust="0"/>
    <p:restoredTop sz="94660"/>
  </p:normalViewPr>
  <p:slideViewPr>
    <p:cSldViewPr snapToGrid="0">
      <p:cViewPr varScale="1">
        <p:scale>
          <a:sx n="77" d="100"/>
          <a:sy n="77" d="100"/>
        </p:scale>
        <p:origin x="451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8/05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8/05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Long-term social and professional outcomes in adults</a:t>
            </a:r>
            <a:br>
              <a:rPr lang="en-GB" sz="2800" b="1" dirty="0">
                <a:solidFill>
                  <a:schemeClr val="bg1"/>
                </a:solidFill>
              </a:rPr>
            </a:br>
            <a:r>
              <a:rPr lang="en-GB" sz="2800" b="1" dirty="0">
                <a:solidFill>
                  <a:schemeClr val="bg1"/>
                </a:solidFill>
              </a:rPr>
              <a:t>after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kidney failure in Switzerland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kidney failure affects social and professional achievements in adulthood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836365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Laube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Adults after pediatric kidney failure are at risk of adverse social and professional outcomes. Increased awareness among healthcare professionals and additional psycho-social support could contribute to mitigate those risks.</a:t>
            </a:r>
            <a:endParaRPr lang="de-CH" dirty="0">
              <a:solidFill>
                <a:schemeClr val="bg1"/>
              </a:solidFill>
            </a:endParaRPr>
          </a:p>
        </p:txBody>
      </p:sp>
      <p:sp>
        <p:nvSpPr>
          <p:cNvPr id="45" name="Rectangle 48">
            <a:extLst>
              <a:ext uri="{FF2B5EF4-FFF2-40B4-BE49-F238E27FC236}">
                <a16:creationId xmlns:a16="http://schemas.microsoft.com/office/drawing/2014/main" id="{9BC6B920-F864-095E-A76A-2F5AA5D5E3C0}"/>
              </a:ext>
            </a:extLst>
          </p:cNvPr>
          <p:cNvSpPr/>
          <p:nvPr/>
        </p:nvSpPr>
        <p:spPr>
          <a:xfrm>
            <a:off x="245160" y="4362159"/>
            <a:ext cx="4435513" cy="610672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80 adult patients with pediatric kidney failure</a:t>
            </a:r>
          </a:p>
        </p:txBody>
      </p:sp>
      <p:sp>
        <p:nvSpPr>
          <p:cNvPr id="60" name="Rectangle 38">
            <a:extLst>
              <a:ext uri="{FF2B5EF4-FFF2-40B4-BE49-F238E27FC236}">
                <a16:creationId xmlns:a16="http://schemas.microsoft.com/office/drawing/2014/main" id="{B3D04A58-1345-B96F-EA70-4B5600C92C90}"/>
              </a:ext>
            </a:extLst>
          </p:cNvPr>
          <p:cNvSpPr/>
          <p:nvPr/>
        </p:nvSpPr>
        <p:spPr>
          <a:xfrm>
            <a:off x="6031682" y="4579981"/>
            <a:ext cx="2717448" cy="694853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Tx/>
              <a:buChar char="-"/>
            </a:pPr>
            <a:r>
              <a:rPr lang="en-GB" sz="1600" dirty="0">
                <a:solidFill>
                  <a:srgbClr val="00437A"/>
                </a:solidFill>
              </a:rPr>
              <a:t>&gt;1 kidney transplantation</a:t>
            </a:r>
          </a:p>
          <a:p>
            <a:pPr marL="285750" indent="-285750">
              <a:buFontTx/>
              <a:buChar char="-"/>
            </a:pPr>
            <a:r>
              <a:rPr lang="en-GB" sz="1600" dirty="0">
                <a:solidFill>
                  <a:srgbClr val="00437A"/>
                </a:solidFill>
              </a:rPr>
              <a:t>On dialysis at study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6DE16DEA-1093-207A-4937-404C67FDB6C2}"/>
              </a:ext>
            </a:extLst>
          </p:cNvPr>
          <p:cNvSpPr txBox="1"/>
          <p:nvPr/>
        </p:nvSpPr>
        <p:spPr>
          <a:xfrm>
            <a:off x="415448" y="2414022"/>
            <a:ext cx="4094935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000" dirty="0">
                <a:solidFill>
                  <a:srgbClr val="296DC0"/>
                </a:solidFill>
              </a:rPr>
              <a:t>Swiss Paediatric Renal Registry (SPRR)</a:t>
            </a:r>
          </a:p>
        </p:txBody>
      </p:sp>
      <p:grpSp>
        <p:nvGrpSpPr>
          <p:cNvPr id="37" name="Gruppieren 36">
            <a:extLst>
              <a:ext uri="{FF2B5EF4-FFF2-40B4-BE49-F238E27FC236}">
                <a16:creationId xmlns:a16="http://schemas.microsoft.com/office/drawing/2014/main" id="{4068FF37-BDB9-B849-DA16-2884D7F6315F}"/>
              </a:ext>
            </a:extLst>
          </p:cNvPr>
          <p:cNvGrpSpPr/>
          <p:nvPr/>
        </p:nvGrpSpPr>
        <p:grpSpPr>
          <a:xfrm>
            <a:off x="1054966" y="2895204"/>
            <a:ext cx="2807476" cy="1101853"/>
            <a:chOff x="1034256" y="2705797"/>
            <a:chExt cx="2807476" cy="1101853"/>
          </a:xfrm>
        </p:grpSpPr>
        <p:pic>
          <p:nvPicPr>
            <p:cNvPr id="32" name="Picture 3" descr="A picture containing text, sign, vector graphics, painted&#10;&#10;Description automatically generated">
              <a:extLst>
                <a:ext uri="{FF2B5EF4-FFF2-40B4-BE49-F238E27FC236}">
                  <a16:creationId xmlns:a16="http://schemas.microsoft.com/office/drawing/2014/main" id="{46809C91-F556-A67D-A4F8-239E102D0F0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4256" y="2755865"/>
              <a:ext cx="1052141" cy="1049898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5" name="Gruppieren 4">
              <a:extLst>
                <a:ext uri="{FF2B5EF4-FFF2-40B4-BE49-F238E27FC236}">
                  <a16:creationId xmlns:a16="http://schemas.microsoft.com/office/drawing/2014/main" id="{2BA476A0-10BD-BB8D-3B54-C7604CB39D9C}"/>
                </a:ext>
              </a:extLst>
            </p:cNvPr>
            <p:cNvGrpSpPr/>
            <p:nvPr/>
          </p:nvGrpSpPr>
          <p:grpSpPr>
            <a:xfrm>
              <a:off x="2526368" y="2705797"/>
              <a:ext cx="1315364" cy="1101853"/>
              <a:chOff x="1677281" y="2705797"/>
              <a:chExt cx="1315364" cy="1101853"/>
            </a:xfrm>
          </p:grpSpPr>
          <p:sp>
            <p:nvSpPr>
              <p:cNvPr id="33" name="Freeform: Shape 46">
                <a:extLst>
                  <a:ext uri="{FF2B5EF4-FFF2-40B4-BE49-F238E27FC236}">
                    <a16:creationId xmlns:a16="http://schemas.microsoft.com/office/drawing/2014/main" id="{83048949-03D9-7783-682B-B53EB33EC7AC}"/>
                  </a:ext>
                </a:extLst>
              </p:cNvPr>
              <p:cNvSpPr/>
              <p:nvPr/>
            </p:nvSpPr>
            <p:spPr>
              <a:xfrm>
                <a:off x="1677281" y="2721325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296DC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34" name="Freeform: Shape 46">
                <a:extLst>
                  <a:ext uri="{FF2B5EF4-FFF2-40B4-BE49-F238E27FC236}">
                    <a16:creationId xmlns:a16="http://schemas.microsoft.com/office/drawing/2014/main" id="{3967DBFF-65BB-6736-2AA9-EDA0A7BFCC76}"/>
                  </a:ext>
                </a:extLst>
              </p:cNvPr>
              <p:cNvSpPr/>
              <p:nvPr/>
            </p:nvSpPr>
            <p:spPr>
              <a:xfrm>
                <a:off x="2209664" y="2705797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00437A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35" name="Freeform: Shape 46">
                <a:extLst>
                  <a:ext uri="{FF2B5EF4-FFF2-40B4-BE49-F238E27FC236}">
                    <a16:creationId xmlns:a16="http://schemas.microsoft.com/office/drawing/2014/main" id="{F7F37B63-7E50-0AA3-7F72-FA85C15DB6DD}"/>
                  </a:ext>
                </a:extLst>
              </p:cNvPr>
              <p:cNvSpPr/>
              <p:nvPr/>
            </p:nvSpPr>
            <p:spPr>
              <a:xfrm>
                <a:off x="1941942" y="2757752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65AA00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  <p:sp>
            <p:nvSpPr>
              <p:cNvPr id="36" name="Freeform: Shape 46">
                <a:extLst>
                  <a:ext uri="{FF2B5EF4-FFF2-40B4-BE49-F238E27FC236}">
                    <a16:creationId xmlns:a16="http://schemas.microsoft.com/office/drawing/2014/main" id="{620D0617-FC71-6DF5-6A06-EEDCEFC9DCE0}"/>
                  </a:ext>
                </a:extLst>
              </p:cNvPr>
              <p:cNvSpPr/>
              <p:nvPr/>
            </p:nvSpPr>
            <p:spPr>
              <a:xfrm>
                <a:off x="2479361" y="2749058"/>
                <a:ext cx="513284" cy="1049898"/>
              </a:xfrm>
              <a:custGeom>
                <a:avLst/>
                <a:gdLst>
                  <a:gd name="connsiteX0" fmla="*/ 427832 w 855663"/>
                  <a:gd name="connsiteY0" fmla="*/ 350043 h 1750218"/>
                  <a:gd name="connsiteX1" fmla="*/ 556181 w 855663"/>
                  <a:gd name="connsiteY1" fmla="*/ 365601 h 1750218"/>
                  <a:gd name="connsiteX2" fmla="*/ 719535 w 855663"/>
                  <a:gd name="connsiteY2" fmla="*/ 451168 h 1750218"/>
                  <a:gd name="connsiteX3" fmla="*/ 742872 w 855663"/>
                  <a:gd name="connsiteY3" fmla="*/ 493950 h 1750218"/>
                  <a:gd name="connsiteX4" fmla="*/ 851774 w 855663"/>
                  <a:gd name="connsiteY4" fmla="*/ 956786 h 1750218"/>
                  <a:gd name="connsiteX5" fmla="*/ 855663 w 855663"/>
                  <a:gd name="connsiteY5" fmla="*/ 976232 h 1750218"/>
                  <a:gd name="connsiteX6" fmla="*/ 777876 w 855663"/>
                  <a:gd name="connsiteY6" fmla="*/ 1054020 h 1750218"/>
                  <a:gd name="connsiteX7" fmla="*/ 703977 w 855663"/>
                  <a:gd name="connsiteY7" fmla="*/ 995680 h 1750218"/>
                  <a:gd name="connsiteX8" fmla="*/ 622301 w 855663"/>
                  <a:gd name="connsiteY8" fmla="*/ 657304 h 1750218"/>
                  <a:gd name="connsiteX9" fmla="*/ 622301 w 855663"/>
                  <a:gd name="connsiteY9" fmla="*/ 1750218 h 1750218"/>
                  <a:gd name="connsiteX10" fmla="*/ 466726 w 855663"/>
                  <a:gd name="connsiteY10" fmla="*/ 1750218 h 1750218"/>
                  <a:gd name="connsiteX11" fmla="*/ 466726 w 855663"/>
                  <a:gd name="connsiteY11" fmla="*/ 1050131 h 1750218"/>
                  <a:gd name="connsiteX12" fmla="*/ 388938 w 855663"/>
                  <a:gd name="connsiteY12" fmla="*/ 1050131 h 1750218"/>
                  <a:gd name="connsiteX13" fmla="*/ 388938 w 855663"/>
                  <a:gd name="connsiteY13" fmla="*/ 1750218 h 1750218"/>
                  <a:gd name="connsiteX14" fmla="*/ 233363 w 855663"/>
                  <a:gd name="connsiteY14" fmla="*/ 1750218 h 1750218"/>
                  <a:gd name="connsiteX15" fmla="*/ 233363 w 855663"/>
                  <a:gd name="connsiteY15" fmla="*/ 661193 h 1750218"/>
                  <a:gd name="connsiteX16" fmla="*/ 151686 w 855663"/>
                  <a:gd name="connsiteY16" fmla="*/ 999569 h 1750218"/>
                  <a:gd name="connsiteX17" fmla="*/ 77788 w 855663"/>
                  <a:gd name="connsiteY17" fmla="*/ 1057910 h 1750218"/>
                  <a:gd name="connsiteX18" fmla="*/ 0 w 855663"/>
                  <a:gd name="connsiteY18" fmla="*/ 980123 h 1750218"/>
                  <a:gd name="connsiteX19" fmla="*/ 3889 w 855663"/>
                  <a:gd name="connsiteY19" fmla="*/ 960675 h 1750218"/>
                  <a:gd name="connsiteX20" fmla="*/ 112792 w 855663"/>
                  <a:gd name="connsiteY20" fmla="*/ 497840 h 1750218"/>
                  <a:gd name="connsiteX21" fmla="*/ 136129 w 855663"/>
                  <a:gd name="connsiteY21" fmla="*/ 455057 h 1750218"/>
                  <a:gd name="connsiteX22" fmla="*/ 299482 w 855663"/>
                  <a:gd name="connsiteY22" fmla="*/ 369490 h 1750218"/>
                  <a:gd name="connsiteX23" fmla="*/ 427832 w 855663"/>
                  <a:gd name="connsiteY23" fmla="*/ 350043 h 1750218"/>
                  <a:gd name="connsiteX24" fmla="*/ 427831 w 855663"/>
                  <a:gd name="connsiteY24" fmla="*/ 0 h 1750218"/>
                  <a:gd name="connsiteX25" fmla="*/ 583406 w 855663"/>
                  <a:gd name="connsiteY25" fmla="*/ 155575 h 1750218"/>
                  <a:gd name="connsiteX26" fmla="*/ 427831 w 855663"/>
                  <a:gd name="connsiteY26" fmla="*/ 311150 h 1750218"/>
                  <a:gd name="connsiteX27" fmla="*/ 272256 w 855663"/>
                  <a:gd name="connsiteY27" fmla="*/ 155575 h 1750218"/>
                  <a:gd name="connsiteX28" fmla="*/ 427831 w 855663"/>
                  <a:gd name="connsiteY28" fmla="*/ 0 h 1750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855663" h="1750218">
                    <a:moveTo>
                      <a:pt x="427832" y="350043"/>
                    </a:moveTo>
                    <a:cubicBezTo>
                      <a:pt x="470615" y="350043"/>
                      <a:pt x="513398" y="357821"/>
                      <a:pt x="556181" y="365601"/>
                    </a:cubicBezTo>
                    <a:cubicBezTo>
                      <a:pt x="618412" y="385047"/>
                      <a:pt x="672862" y="412273"/>
                      <a:pt x="719535" y="451168"/>
                    </a:cubicBezTo>
                    <a:cubicBezTo>
                      <a:pt x="731203" y="462835"/>
                      <a:pt x="738983" y="478392"/>
                      <a:pt x="742872" y="493950"/>
                    </a:cubicBezTo>
                    <a:lnTo>
                      <a:pt x="851774" y="956786"/>
                    </a:lnTo>
                    <a:cubicBezTo>
                      <a:pt x="851774" y="960675"/>
                      <a:pt x="855663" y="968454"/>
                      <a:pt x="855663" y="976232"/>
                    </a:cubicBezTo>
                    <a:cubicBezTo>
                      <a:pt x="855663" y="1019016"/>
                      <a:pt x="820659" y="1054020"/>
                      <a:pt x="777876" y="1054020"/>
                    </a:cubicBezTo>
                    <a:cubicBezTo>
                      <a:pt x="742872" y="1054020"/>
                      <a:pt x="711757" y="1026795"/>
                      <a:pt x="703977" y="995680"/>
                    </a:cubicBezTo>
                    <a:lnTo>
                      <a:pt x="622301" y="657304"/>
                    </a:lnTo>
                    <a:lnTo>
                      <a:pt x="622301" y="1750218"/>
                    </a:lnTo>
                    <a:lnTo>
                      <a:pt x="466726" y="1750218"/>
                    </a:lnTo>
                    <a:lnTo>
                      <a:pt x="466726" y="1050131"/>
                    </a:lnTo>
                    <a:lnTo>
                      <a:pt x="388938" y="1050131"/>
                    </a:lnTo>
                    <a:lnTo>
                      <a:pt x="388938" y="1750218"/>
                    </a:lnTo>
                    <a:lnTo>
                      <a:pt x="233363" y="1750218"/>
                    </a:lnTo>
                    <a:lnTo>
                      <a:pt x="233363" y="661193"/>
                    </a:lnTo>
                    <a:lnTo>
                      <a:pt x="151686" y="999569"/>
                    </a:lnTo>
                    <a:cubicBezTo>
                      <a:pt x="143907" y="1030684"/>
                      <a:pt x="112792" y="1057910"/>
                      <a:pt x="77788" y="1057910"/>
                    </a:cubicBezTo>
                    <a:cubicBezTo>
                      <a:pt x="35004" y="1057910"/>
                      <a:pt x="0" y="1022905"/>
                      <a:pt x="0" y="980123"/>
                    </a:cubicBezTo>
                    <a:cubicBezTo>
                      <a:pt x="0" y="972343"/>
                      <a:pt x="3889" y="964564"/>
                      <a:pt x="3889" y="960675"/>
                    </a:cubicBezTo>
                    <a:lnTo>
                      <a:pt x="112792" y="497840"/>
                    </a:lnTo>
                    <a:cubicBezTo>
                      <a:pt x="116682" y="482281"/>
                      <a:pt x="124460" y="466725"/>
                      <a:pt x="136129" y="455057"/>
                    </a:cubicBezTo>
                    <a:cubicBezTo>
                      <a:pt x="182801" y="416162"/>
                      <a:pt x="237252" y="385047"/>
                      <a:pt x="299482" y="369490"/>
                    </a:cubicBezTo>
                    <a:cubicBezTo>
                      <a:pt x="342265" y="357821"/>
                      <a:pt x="385049" y="350043"/>
                      <a:pt x="427832" y="350043"/>
                    </a:cubicBezTo>
                    <a:close/>
                    <a:moveTo>
                      <a:pt x="427831" y="0"/>
                    </a:moveTo>
                    <a:cubicBezTo>
                      <a:pt x="513753" y="0"/>
                      <a:pt x="583406" y="69653"/>
                      <a:pt x="583406" y="155575"/>
                    </a:cubicBezTo>
                    <a:cubicBezTo>
                      <a:pt x="583406" y="241496"/>
                      <a:pt x="513753" y="311150"/>
                      <a:pt x="427831" y="311150"/>
                    </a:cubicBezTo>
                    <a:cubicBezTo>
                      <a:pt x="341910" y="311150"/>
                      <a:pt x="272256" y="241496"/>
                      <a:pt x="272256" y="155575"/>
                    </a:cubicBezTo>
                    <a:cubicBezTo>
                      <a:pt x="272256" y="69653"/>
                      <a:pt x="341910" y="0"/>
                      <a:pt x="427831" y="0"/>
                    </a:cubicBezTo>
                    <a:close/>
                  </a:path>
                </a:pathLst>
              </a:custGeom>
              <a:solidFill>
                <a:srgbClr val="AA0065"/>
              </a:solidFill>
              <a:ln w="15081" cap="flat">
                <a:noFill/>
                <a:prstDash val="solid"/>
                <a:miter/>
              </a:ln>
            </p:spPr>
            <p:txBody>
              <a:bodyPr wrap="square" rtlCol="0" anchor="ctr">
                <a:noAutofit/>
              </a:bodyPr>
              <a:lstStyle/>
              <a:p>
                <a:endParaRPr lang="en-US"/>
              </a:p>
            </p:txBody>
          </p:sp>
        </p:grpSp>
      </p:grpSp>
      <p:sp>
        <p:nvSpPr>
          <p:cNvPr id="31" name="Textfeld 30">
            <a:extLst>
              <a:ext uri="{FF2B5EF4-FFF2-40B4-BE49-F238E27FC236}">
                <a16:creationId xmlns:a16="http://schemas.microsoft.com/office/drawing/2014/main" id="{FDB7060F-BDF8-84CD-ED4F-9BFD4E25C5C7}"/>
              </a:ext>
            </a:extLst>
          </p:cNvPr>
          <p:cNvSpPr txBox="1"/>
          <p:nvPr/>
        </p:nvSpPr>
        <p:spPr>
          <a:xfrm>
            <a:off x="5893919" y="4066391"/>
            <a:ext cx="4652677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000" dirty="0">
                <a:solidFill>
                  <a:srgbClr val="296DC0"/>
                </a:solidFill>
              </a:rPr>
              <a:t>Factors associated with adverse outcomes</a:t>
            </a:r>
          </a:p>
        </p:txBody>
      </p:sp>
      <p:sp>
        <p:nvSpPr>
          <p:cNvPr id="51" name="Up Arrow 74">
            <a:extLst>
              <a:ext uri="{FF2B5EF4-FFF2-40B4-BE49-F238E27FC236}">
                <a16:creationId xmlns:a16="http://schemas.microsoft.com/office/drawing/2014/main" id="{EF2BA3B8-35B0-725E-0225-2FA0AA7672EB}"/>
              </a:ext>
            </a:extLst>
          </p:cNvPr>
          <p:cNvSpPr/>
          <p:nvPr/>
        </p:nvSpPr>
        <p:spPr>
          <a:xfrm rot="5400000">
            <a:off x="5455802" y="4022058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D907F8C6-9CD6-5803-70A1-D4E69F688FB0}"/>
              </a:ext>
            </a:extLst>
          </p:cNvPr>
          <p:cNvGrpSpPr/>
          <p:nvPr/>
        </p:nvGrpSpPr>
        <p:grpSpPr>
          <a:xfrm>
            <a:off x="5368101" y="2063280"/>
            <a:ext cx="6429348" cy="400110"/>
            <a:chOff x="5029061" y="2063280"/>
            <a:chExt cx="6429348" cy="400110"/>
          </a:xfrm>
        </p:grpSpPr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3E437030-9CC4-5207-CC11-D3EC81C69526}"/>
                </a:ext>
              </a:extLst>
            </p:cNvPr>
            <p:cNvSpPr txBox="1"/>
            <p:nvPr/>
          </p:nvSpPr>
          <p:spPr>
            <a:xfrm>
              <a:off x="5554881" y="2063280"/>
              <a:ext cx="5903528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GB" sz="2000" dirty="0">
                  <a:solidFill>
                    <a:srgbClr val="296DC0"/>
                  </a:solidFill>
                </a:rPr>
                <a:t>Comparison to general population:</a:t>
              </a:r>
            </a:p>
          </p:txBody>
        </p:sp>
        <p:sp>
          <p:nvSpPr>
            <p:cNvPr id="52" name="Up Arrow 74">
              <a:extLst>
                <a:ext uri="{FF2B5EF4-FFF2-40B4-BE49-F238E27FC236}">
                  <a16:creationId xmlns:a16="http://schemas.microsoft.com/office/drawing/2014/main" id="{47310394-1B8D-395E-2072-3F2547E5C3B7}"/>
                </a:ext>
              </a:extLst>
            </p:cNvPr>
            <p:cNvSpPr/>
            <p:nvPr/>
          </p:nvSpPr>
          <p:spPr>
            <a:xfrm rot="5400000">
              <a:off x="5116762" y="2024947"/>
              <a:ext cx="301374" cy="476776"/>
            </a:xfrm>
            <a:prstGeom prst="upArrow">
              <a:avLst>
                <a:gd name="adj1" fmla="val 0"/>
                <a:gd name="adj2" fmla="val 108703"/>
              </a:avLst>
            </a:prstGeom>
            <a:solidFill>
              <a:srgbClr val="296D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4" name="Rectangle 38">
            <a:extLst>
              <a:ext uri="{FF2B5EF4-FFF2-40B4-BE49-F238E27FC236}">
                <a16:creationId xmlns:a16="http://schemas.microsoft.com/office/drawing/2014/main" id="{8184C3B7-C7CE-7E91-B77D-AF7EF4BD41D2}"/>
              </a:ext>
            </a:extLst>
          </p:cNvPr>
          <p:cNvSpPr/>
          <p:nvPr/>
        </p:nvSpPr>
        <p:spPr>
          <a:xfrm>
            <a:off x="6031681" y="2581046"/>
            <a:ext cx="3348579" cy="110335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600" dirty="0">
              <a:solidFill>
                <a:srgbClr val="00437A"/>
              </a:solidFill>
            </a:endParaRPr>
          </a:p>
          <a:p>
            <a:pPr marL="285750" indent="-285750">
              <a:buFontTx/>
              <a:buChar char="-"/>
            </a:pPr>
            <a:r>
              <a:rPr lang="en-GB" sz="1600" dirty="0">
                <a:solidFill>
                  <a:srgbClr val="AA0065"/>
                </a:solidFill>
              </a:rPr>
              <a:t>Less often in a partner relationship</a:t>
            </a:r>
          </a:p>
          <a:p>
            <a:pPr marL="285750" indent="-285750">
              <a:buFontTx/>
              <a:buChar char="-"/>
            </a:pPr>
            <a:r>
              <a:rPr lang="en-GB" sz="1600" dirty="0">
                <a:solidFill>
                  <a:srgbClr val="AA0065"/>
                </a:solidFill>
              </a:rPr>
              <a:t>More often living alone</a:t>
            </a:r>
          </a:p>
          <a:p>
            <a:pPr marL="285750" indent="-285750">
              <a:buFontTx/>
              <a:buChar char="-"/>
            </a:pPr>
            <a:r>
              <a:rPr lang="en-GB" sz="1600" dirty="0">
                <a:solidFill>
                  <a:srgbClr val="AA0065"/>
                </a:solidFill>
              </a:rPr>
              <a:t>More often without children</a:t>
            </a:r>
          </a:p>
          <a:p>
            <a:pPr marL="285750" indent="-285750">
              <a:buFontTx/>
              <a:buChar char="-"/>
            </a:pPr>
            <a:r>
              <a:rPr lang="en-GB" sz="1600" dirty="0">
                <a:solidFill>
                  <a:srgbClr val="AA0065"/>
                </a:solidFill>
              </a:rPr>
              <a:t>More often unemployed</a:t>
            </a:r>
          </a:p>
          <a:p>
            <a:endParaRPr lang="en-GB" sz="1600" dirty="0">
              <a:solidFill>
                <a:srgbClr val="00437A"/>
              </a:solidFill>
            </a:endParaRPr>
          </a:p>
        </p:txBody>
      </p:sp>
      <p:sp>
        <p:nvSpPr>
          <p:cNvPr id="7" name="Rectangle 38">
            <a:extLst>
              <a:ext uri="{FF2B5EF4-FFF2-40B4-BE49-F238E27FC236}">
                <a16:creationId xmlns:a16="http://schemas.microsoft.com/office/drawing/2014/main" id="{A47FDEEE-34D3-83E0-A04E-9FAB01A76C40}"/>
              </a:ext>
            </a:extLst>
          </p:cNvPr>
          <p:cNvSpPr/>
          <p:nvPr/>
        </p:nvSpPr>
        <p:spPr>
          <a:xfrm>
            <a:off x="9644922" y="2889722"/>
            <a:ext cx="1996437" cy="457667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285750" indent="-285750">
              <a:buFontTx/>
              <a:buChar char="-"/>
            </a:pPr>
            <a:r>
              <a:rPr lang="en-GB" sz="1600" dirty="0">
                <a:solidFill>
                  <a:srgbClr val="65AA00"/>
                </a:solidFill>
              </a:rPr>
              <a:t>Similar education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20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106</cp:revision>
  <dcterms:created xsi:type="dcterms:W3CDTF">2019-06-13T12:30:18Z</dcterms:created>
  <dcterms:modified xsi:type="dcterms:W3CDTF">2023-05-18T11:55:33Z</dcterms:modified>
</cp:coreProperties>
</file>